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468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717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81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76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836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205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076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440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821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26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230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6E305-819B-428B-BF7E-2358B72C3288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E02BA-9C12-4DAB-903A-6E5191CD6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43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583474"/>
            <a:ext cx="8663895" cy="5121548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721895" y="579709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6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Calibri" panose="020F0502020204030204" pitchFamily="34" charset="0"/>
                <a:ea typeface="MS Mincho"/>
                <a:cs typeface="Times New Roman" panose="02020603050405020304" pitchFamily="18" charset="0"/>
              </a:rPr>
              <a:t>­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for deprotected chloroquinolines against sensitive strain 3D7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6614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7:36Z</dcterms:created>
  <dcterms:modified xsi:type="dcterms:W3CDTF">2020-08-04T16:31:35Z</dcterms:modified>
</cp:coreProperties>
</file>